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73" autoAdjust="0"/>
    <p:restoredTop sz="97291" autoAdjust="0"/>
  </p:normalViewPr>
  <p:slideViewPr>
    <p:cSldViewPr snapToGrid="0">
      <p:cViewPr>
        <p:scale>
          <a:sx n="100" d="100"/>
          <a:sy n="100" d="100"/>
        </p:scale>
        <p:origin x="-72" y="-4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330EC2-33A7-456A-95F8-11E59DBC6986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25B5D8-2342-4413-A6BE-5027777405A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6430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5A359-8DB3-49A0-99B8-C377D858E092}" type="datetimeFigureOut">
              <a:rPr lang="zh-TW" altLang="en-US" smtClean="0"/>
              <a:pPr/>
              <a:t>2014/9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181403-ACDA-4AC0-B265-6096EFCD1F8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3009303"/>
              </p:ext>
            </p:extLst>
          </p:nvPr>
        </p:nvGraphicFramePr>
        <p:xfrm>
          <a:off x="333375" y="234950"/>
          <a:ext cx="8477988" cy="6366993"/>
        </p:xfrm>
        <a:graphic>
          <a:graphicData uri="http://schemas.openxmlformats.org/drawingml/2006/table">
            <a:tbl>
              <a:tblPr/>
              <a:tblGrid>
                <a:gridCol w="356326"/>
                <a:gridCol w="478618"/>
                <a:gridCol w="478618"/>
                <a:gridCol w="478618"/>
                <a:gridCol w="1662547"/>
                <a:gridCol w="427511"/>
                <a:gridCol w="914400"/>
                <a:gridCol w="451263"/>
                <a:gridCol w="1662041"/>
                <a:gridCol w="522682"/>
                <a:gridCol w="522682"/>
                <a:gridCol w="522682"/>
              </a:tblGrid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latin typeface="Calibri"/>
                          <a:ea typeface="新細明體"/>
                          <a:cs typeface="Calibri"/>
                        </a:rPr>
                        <a:t>nam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Predicted In*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latin typeface="Calibri"/>
                          <a:ea typeface="新細明體"/>
                          <a:cs typeface="Calibri"/>
                        </a:rPr>
                        <a:t>location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strand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latin typeface="Calibri"/>
                          <a:ea typeface="新細明體"/>
                          <a:cs typeface="Calibri"/>
                        </a:rPr>
                        <a:t>Region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Arm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Sequenc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latin typeface="Calibri"/>
                          <a:ea typeface="新細明體"/>
                          <a:cs typeface="Calibri"/>
                        </a:rPr>
                        <a:t>Expression value (</a:t>
                      </a:r>
                      <a:r>
                        <a:rPr lang="en-US" sz="800" b="1" kern="0" dirty="0" smtClean="0">
                          <a:latin typeface="Calibri"/>
                          <a:ea typeface="新細明體"/>
                          <a:cs typeface="Calibri"/>
                        </a:rPr>
                        <a:t>RPM</a:t>
                      </a:r>
                      <a:r>
                        <a:rPr lang="en-US" sz="800" b="1" kern="0" dirty="0">
                          <a:latin typeface="Calibri"/>
                          <a:ea typeface="新細明體"/>
                          <a:cs typeface="Calibri"/>
                        </a:rPr>
                        <a:t>)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eEP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 dirty="0" smtClean="0">
                          <a:latin typeface="Calibri"/>
                          <a:ea typeface="新細明體"/>
                          <a:cs typeface="Calibri"/>
                        </a:rPr>
                        <a:t>LEPC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4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:201719847-20171993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CGAUCUCAGAAAGGCAGGC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605.53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34</a:t>
                      </a:r>
                      <a:r>
                        <a:rPr lang="zh-TW" sz="800" kern="100" dirty="0" smtClean="0">
                          <a:latin typeface="Calibri"/>
                          <a:cs typeface="Times New Roman"/>
                        </a:rPr>
                        <a:t> </a:t>
                      </a:r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:214673346-214673426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PTPN14)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AUGAGAAAAUGUCCCACAUU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56.92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09.0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UGUGUGACAUUUUCUCAUUC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0.92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54.52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47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2:74766433-74766510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LOXL3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AGUUCAAUGGUGUUCAGC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830.1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26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2:218905705-218905777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AGAGAACCAUCUGAAAGAC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558.93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CUUUCAGAUGGUUCUCU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4.41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48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2:219144840-21914491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TMBIM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UGGGAUUGACGCCACAUGU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953.32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454.1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327.1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GUCAAGUGUCAUCUGUCCCU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81.33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0.2769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99.58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3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3:11205388-1120546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HRH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AGAUUAUAUGUGUUCUCAUG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25.5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35.38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09.0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UGAACACAUAUAAUCAUAG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02.77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18.10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3:52557364-52557451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STAB1/FELE-1)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AACAGGCCUUGCUCUGCUCAC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044.27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724.01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417.24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GGCAGAGCAGAGCCUGCAUUGG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63.85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451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49.91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0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3:123811937-123812018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CCUCUCCCUCCUUGCUCCUA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651.61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231.2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3:127305945-12730602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TPRA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AUCAAAAGCCUCAGGGC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511.58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28.4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CCCUGAGACUUUUGCUCUA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53.47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340.61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36.31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28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3:143501957-14350203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SLC9A9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GUUGUAGGAUGCUAAAC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502.70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9.0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UUUAGCAUCCUGUAGCCU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23.1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1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4:7087104-708718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ACUGGGCAUGUUGGAACUA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47.3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5:94251393-9425147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MCTP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AACUUGACUUACAGGGUGAA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086.0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04.31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6:13163039-1316311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PHACTR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AGGAACUCCAGACUGUUGGU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7.66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05.53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872.42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6:21686188-21686267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FLJ22536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UAGGAGCAUGAACCUGGUG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448.02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834.4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58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6:142308565-14230864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ACAAAAUCAAACACGGUAGU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59.6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27.1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ACUUUGUUUGAUUUUGUUU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2.3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475.7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.3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8:131429611-13142970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CCACAGAGGAAACGGGCU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488.33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302.77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654.3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0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9:75773363-75773448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ANXA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GCAUCUAACUGUUUUCUUUCC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89.52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46.92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49.63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0:5729060-572914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C10orf18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AAUAUGUACUGACAAAGCG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83.6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302.77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654.3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UUUGUCAGUACAUGUUAAU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0.46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218.10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3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0:94624500-9462457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EXOC6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AGGUCUUCAGACUGUGGG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93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6358.15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4798.33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CCCCCUGGUUUGCAGGCCUU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54.52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11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0:99635571-9963565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CRTAC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GUGCCAUUCUGAGGGCCAGG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2085.09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9.96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UGGCUGCUAUGGCCCCCU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581.51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933.01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2:29715494-29715581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CUGGAUUUGGAGUCAGA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41155.3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390.99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7166.2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7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2:66644861-6664493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'UTR (IRAK3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CUCUAGAAAGAUUGUUGAC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4259.29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3.76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199.58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6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2:104824822-104824906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GGGCAGCUCUUUGCAGU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8.25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54.3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70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3:50552832-5055291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GGUAGAAAUCCAGAAUCUGAG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82.07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573.71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1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3:110889365-11088944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 err="1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</a:t>
                      </a: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 (COL4A1)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GACUGCUGGAGGACCACAAA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387.6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899.3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UGGGGCCCUGGGCAGACCUC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66.53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20.5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7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4:88332013-8833210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UGAAUUAGUGAGAAGACAG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5.6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30.2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7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4:94579976-9458005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IFI27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UUGUGUGUCAGGGUGCAGGU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7.66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797.6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GCCUCCAGACACACCGC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02.77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1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5:48873175-4887324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FBN1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GCUGUGAUGAUGUUCUG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7.66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211.07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763.37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7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6:81567501-81567576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CMIP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GAGGUGACCGCAGAUGGG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44.59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1322.18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100" dirty="0" smtClean="0">
                          <a:latin typeface="Calibri"/>
                          <a:ea typeface="新細明體"/>
                          <a:cs typeface="Times New Roman"/>
                        </a:rPr>
                        <a:t>359.87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17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7:504667-50474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VPS53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UGAUGAUGAGAGAGGCUGAA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040.85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825.45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79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LA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9:13051290-1305137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CALR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UGGAGGGUGUGGAAGACAU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330.12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31.1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863.1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9:35652419-35652495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FXYD5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CAUGUCUGAACCAAUGAG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976.66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059.69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654.31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80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9:52303187-52303274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ronic (FPR3)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UAGCCCAUGGCUCGAUCCUC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81.33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3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9:55837136-55837213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3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GAGAGGGGAUGUAGACGUCUA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71.99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81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19:55995548-55995622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-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CCCGGGGAGCCCCGCGGGG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315.852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874.034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3535.15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248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N87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EE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TW" sz="800" kern="100" dirty="0">
                        <a:latin typeface="Calibri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chrX:47666470-47666558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+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intergeni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5p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Calibri"/>
                        </a:rPr>
                        <a:t>AGGUAGGAUUAGAUCAUUAGC</a:t>
                      </a:r>
                      <a:endParaRPr lang="zh-TW" sz="800" kern="10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511.58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79.29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800" kern="0" dirty="0" smtClean="0">
                          <a:solidFill>
                            <a:srgbClr val="000000"/>
                          </a:solidFill>
                          <a:latin typeface="Calibri"/>
                          <a:ea typeface="新細明體"/>
                          <a:cs typeface="Times New Roman"/>
                        </a:rPr>
                        <a:t>114.246</a:t>
                      </a:r>
                      <a:endParaRPr lang="zh-TW" sz="800" kern="100" dirty="0">
                        <a:latin typeface="Calibri"/>
                        <a:ea typeface="新細明體"/>
                        <a:cs typeface="Times New Roman"/>
                      </a:endParaRPr>
                    </a:p>
                  </a:txBody>
                  <a:tcPr marL="17806" marR="1780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760" name="Text Box 1"/>
          <p:cNvSpPr txBox="1">
            <a:spLocks noChangeArrowheads="1"/>
          </p:cNvSpPr>
          <p:nvPr/>
        </p:nvSpPr>
        <p:spPr bwMode="auto">
          <a:xfrm>
            <a:off x="344488" y="6605588"/>
            <a:ext cx="5740400" cy="265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/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*EE, </a:t>
            </a:r>
            <a:r>
              <a:rPr lang="en-US" altLang="zh-TW" sz="1000" u="sng" dirty="0">
                <a:latin typeface="Calibri" pitchFamily="34" charset="0"/>
                <a:cs typeface="Times New Roman" pitchFamily="18" charset="0"/>
              </a:rPr>
              <a:t>e</a:t>
            </a:r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arly </a:t>
            </a:r>
            <a:r>
              <a:rPr lang="en-US" altLang="zh-TW" sz="1000" u="sng" dirty="0">
                <a:latin typeface="Calibri" pitchFamily="34" charset="0"/>
                <a:cs typeface="Times New Roman" pitchFamily="18" charset="0"/>
              </a:rPr>
              <a:t>E</a:t>
            </a:r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PC. LA, </a:t>
            </a:r>
            <a:r>
              <a:rPr lang="en-US" altLang="zh-TW" sz="1000" u="sng" dirty="0">
                <a:latin typeface="Calibri" pitchFamily="34" charset="0"/>
                <a:cs typeface="Times New Roman" pitchFamily="18" charset="0"/>
              </a:rPr>
              <a:t>la</a:t>
            </a:r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te EPC. EC, mature </a:t>
            </a:r>
            <a:r>
              <a:rPr lang="en-US" altLang="zh-TW" sz="1000" u="sng" dirty="0">
                <a:latin typeface="Calibri" pitchFamily="34" charset="0"/>
                <a:cs typeface="Times New Roman" pitchFamily="18" charset="0"/>
              </a:rPr>
              <a:t>e</a:t>
            </a:r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ndothelial </a:t>
            </a:r>
            <a:r>
              <a:rPr lang="en-US" altLang="zh-TW" sz="1000" u="sng" dirty="0">
                <a:latin typeface="Calibri" pitchFamily="34" charset="0"/>
                <a:cs typeface="Times New Roman" pitchFamily="18" charset="0"/>
              </a:rPr>
              <a:t>c</a:t>
            </a:r>
            <a:r>
              <a:rPr lang="en-US" altLang="zh-TW" sz="1000" dirty="0">
                <a:latin typeface="Calibri" pitchFamily="34" charset="0"/>
                <a:cs typeface="Times New Roman" pitchFamily="18" charset="0"/>
              </a:rPr>
              <a:t>ell.</a:t>
            </a:r>
            <a:endParaRPr lang="en-US" altLang="zh-TW" dirty="0"/>
          </a:p>
        </p:txBody>
      </p:sp>
      <p:sp>
        <p:nvSpPr>
          <p:cNvPr id="10761" name="Rectangle 3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endParaRPr lang="zh-TW" altLang="zh-TW"/>
          </a:p>
        </p:txBody>
      </p:sp>
      <p:sp>
        <p:nvSpPr>
          <p:cNvPr id="10762" name="Rectangle 4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endParaRPr lang="zh-TW" altLang="zh-TW"/>
          </a:p>
        </p:txBody>
      </p:sp>
      <p:sp>
        <p:nvSpPr>
          <p:cNvPr id="7" name="矩形 6"/>
          <p:cNvSpPr/>
          <p:nvPr/>
        </p:nvSpPr>
        <p:spPr>
          <a:xfrm>
            <a:off x="247650" y="0"/>
            <a:ext cx="216309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  <a:defRPr/>
            </a:pPr>
            <a:r>
              <a:rPr lang="en-US" altLang="zh-TW" sz="1100" b="1" kern="100" smtClean="0">
                <a:latin typeface="Calibri"/>
                <a:ea typeface="新細明體"/>
                <a:cs typeface="Times New Roman"/>
              </a:rPr>
              <a:t>Table S5</a:t>
            </a:r>
            <a:r>
              <a:rPr lang="en-US" altLang="zh-TW" sz="1100" b="1" kern="100" dirty="0" smtClean="0">
                <a:latin typeface="Calibri"/>
                <a:ea typeface="新細明體"/>
                <a:cs typeface="Times New Roman"/>
              </a:rPr>
              <a:t>. </a:t>
            </a:r>
            <a:r>
              <a:rPr lang="en-US" altLang="zh-TW" sz="1100" b="1" kern="100" dirty="0">
                <a:latin typeface="Calibri"/>
                <a:ea typeface="新細明體"/>
                <a:cs typeface="Times New Roman"/>
              </a:rPr>
              <a:t>Predicted Novel miRNAs</a:t>
            </a:r>
            <a:endParaRPr lang="zh-TW" altLang="zh-TW" sz="1100" kern="100" dirty="0">
              <a:latin typeface="Calibri"/>
              <a:ea typeface="新細明體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98</TotalTime>
  <Words>546</Words>
  <Application>Microsoft Office PowerPoint</Application>
  <PresentationFormat>如螢幕大小 (4:3)</PresentationFormat>
  <Paragraphs>450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hwwang</dc:creator>
  <cp:lastModifiedBy>Ting-Yu Chang</cp:lastModifiedBy>
  <cp:revision>283</cp:revision>
  <dcterms:created xsi:type="dcterms:W3CDTF">2013-03-27T03:09:17Z</dcterms:created>
  <dcterms:modified xsi:type="dcterms:W3CDTF">2014-09-08T18:25:55Z</dcterms:modified>
</cp:coreProperties>
</file>